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90" autoAdjust="0"/>
    <p:restoredTop sz="94660"/>
  </p:normalViewPr>
  <p:slideViewPr>
    <p:cSldViewPr snapToGrid="0">
      <p:cViewPr>
        <p:scale>
          <a:sx n="117" d="100"/>
          <a:sy n="117" d="100"/>
        </p:scale>
        <p:origin x="-300" y="-1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0FF9F-9DBA-4780-B8CB-ACF16B2838FF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572E27-075B-4748-ACEB-A968272CCE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94482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A8E08F2-CD96-AFD3-E99E-CD9051E7DC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C1DA46C3-F825-D4ED-7593-B86979402C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CD20CB5A-8176-AF7A-61B9-DDACF560F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D3C9D63-BE8B-DE9E-1782-96513312E2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D4F52AE-2483-7EE2-4A50-033A5C7BB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011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6E485BA-171A-4276-45E5-0080DA1371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1EB3B466-0A7A-11E4-1D4B-DF53E46587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A19CA19-4EDE-FBA9-DCE2-9D6BA0D29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887879D-8314-2DAE-45B7-447CD4A66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078FF22-3EAF-0433-04A2-CBAD57E0E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5002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6CE95C6A-483E-1A51-C650-47E4EF8DE5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7C50648B-BFF6-733A-792E-7BBA5173C0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A2ED8F6-8455-E66D-6498-250BA3FF6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115C20FD-2C20-A1F3-2173-FA6E0C510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42C65AD-23AF-9EC5-3B5B-FD71A5455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5438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EE6F6DF-90D1-69F5-3AE4-BFCBDAAE27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D0C4834-610F-C030-F176-573BC7738F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EE91F1F-38BA-C3E3-34A8-3CEB9C315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24E4BAC1-B709-E900-68C5-D4A2D6CCB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B907A39-47E4-8009-EFB2-826F6633D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0459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CAC6268-989B-39A4-86D7-2A317FFBBC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2573BAA-9100-D518-1384-0B71857DAC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E773330-CD46-F8A2-CDB4-DA2446122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1617213-04CC-44DF-0E3A-9B561B4FD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68AAADC-53DE-5EF7-903A-2AC24FB1C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8635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FD423D2-0E5F-3B5C-365B-454B824A8E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8A3142FC-98EC-8C24-9AB9-4955E8032A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A9A72BA8-D674-FA5F-660F-4BF9AD0D40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05C1A494-E1B9-3451-F6CB-5A138228E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035F805-5E2B-8FB7-6543-DFFAE36DB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EEC14499-A49E-CF80-65CE-C11C8A0079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4338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4F1613A-44C2-90DE-91C5-646FCF6177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FA64F948-35CA-AB9D-96B7-CEA7371C3F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363E630B-8C12-F5B0-D9B7-F45486F0A1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5CE76379-374F-6969-8F3C-6928A958DC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A5291CF9-A8AC-C8B7-3DFF-27067A0CAA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59F59447-8901-7B0F-A3D2-03127BF9B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1D0070DB-4DD7-FC0E-674F-90B19D7DD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0220F788-0ACA-7F1A-9AA6-11FD3C4F89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068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C388C80-0F0D-060D-4E48-B71F4E694B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0A5B2A60-AAF0-B8EE-7C7F-07B69812F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CFC5A8E5-0D31-4B59-F770-8F3F59DD4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2C6C7601-0245-C533-EA1E-CA9DA165A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2361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6141E2D3-3DCA-3242-BD52-F271BE431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EEB7AA2-B797-9F24-D94E-A69374F29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E0080331-BF9D-3AF7-4800-C10AAE98D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1035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5D6410F-E269-1997-F9F4-3238CC55FA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5DB781A3-6531-133F-D18C-D679E1D9F8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DFBAB09-6C43-936E-F9A8-FCB4775A35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009F9F3-AADF-B0D2-47A4-F9E47C8E9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10CA547-27DE-7A11-CC1D-46E95A992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98F66083-1674-D762-F401-2D84167B4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8153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2522A24-8B25-D42A-964F-1854BBEA3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74C343E9-4034-D413-ADCC-BA914D2165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7DF9B83-4CE2-FEF5-432A-90E520B46A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1674F34A-1B72-A366-18F5-3B33F32BF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8847B6E3-04BD-FEF0-41E2-1C9B08360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1BF48B54-43FD-83CE-347D-DDB2EC69C3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1216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89DF563C-5196-2D1E-E9D8-9903DC66EB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E5A6C58E-42EA-ED7F-EE74-A6322E5B77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5D14AEB-4A52-EB2C-8DCC-92428A3881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B67DC8-73C0-4DD0-8916-862B54B75DF7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033A32B-36A5-66AD-1986-6F66D68C28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DBEC55DA-AFE6-3447-7001-F6E6AD3E87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F22C8-7F54-4B07-9664-BADB46E086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2823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881DDE2D-41D9-59FC-0DF5-181B90F7EB1A}"/>
              </a:ext>
            </a:extLst>
          </p:cNvPr>
          <p:cNvSpPr txBox="1"/>
          <p:nvPr/>
        </p:nvSpPr>
        <p:spPr>
          <a:xfrm>
            <a:off x="1822495" y="717120"/>
            <a:ext cx="808298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1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tical performance characteristics of the commercial assay kits used in this study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xmlns="" id="{C354BB73-5E08-FBD1-0BE4-CC0E643083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7534689"/>
              </p:ext>
            </p:extLst>
          </p:nvPr>
        </p:nvGraphicFramePr>
        <p:xfrm>
          <a:off x="1184779" y="1248629"/>
          <a:ext cx="9358411" cy="498149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691075">
                  <a:extLst>
                    <a:ext uri="{9D8B030D-6E8A-4147-A177-3AD203B41FA5}">
                      <a16:colId xmlns:a16="http://schemas.microsoft.com/office/drawing/2014/main" xmlns="" val="1462270159"/>
                    </a:ext>
                  </a:extLst>
                </a:gridCol>
                <a:gridCol w="2241238">
                  <a:extLst>
                    <a:ext uri="{9D8B030D-6E8A-4147-A177-3AD203B41FA5}">
                      <a16:colId xmlns:a16="http://schemas.microsoft.com/office/drawing/2014/main" xmlns="" val="1524501047"/>
                    </a:ext>
                  </a:extLst>
                </a:gridCol>
                <a:gridCol w="1498292">
                  <a:extLst>
                    <a:ext uri="{9D8B030D-6E8A-4147-A177-3AD203B41FA5}">
                      <a16:colId xmlns:a16="http://schemas.microsoft.com/office/drawing/2014/main" xmlns="" val="3912337121"/>
                    </a:ext>
                  </a:extLst>
                </a:gridCol>
                <a:gridCol w="891761">
                  <a:extLst>
                    <a:ext uri="{9D8B030D-6E8A-4147-A177-3AD203B41FA5}">
                      <a16:colId xmlns:a16="http://schemas.microsoft.com/office/drawing/2014/main" xmlns="" val="2791688055"/>
                    </a:ext>
                  </a:extLst>
                </a:gridCol>
                <a:gridCol w="891761">
                  <a:extLst>
                    <a:ext uri="{9D8B030D-6E8A-4147-A177-3AD203B41FA5}">
                      <a16:colId xmlns:a16="http://schemas.microsoft.com/office/drawing/2014/main" xmlns="" val="3715776412"/>
                    </a:ext>
                  </a:extLst>
                </a:gridCol>
                <a:gridCol w="886123">
                  <a:extLst>
                    <a:ext uri="{9D8B030D-6E8A-4147-A177-3AD203B41FA5}">
                      <a16:colId xmlns:a16="http://schemas.microsoft.com/office/drawing/2014/main" xmlns="" val="2457854505"/>
                    </a:ext>
                  </a:extLst>
                </a:gridCol>
                <a:gridCol w="1258161">
                  <a:extLst>
                    <a:ext uri="{9D8B030D-6E8A-4147-A177-3AD203B41FA5}">
                      <a16:colId xmlns:a16="http://schemas.microsoft.com/office/drawing/2014/main" xmlns="" val="1131295690"/>
                    </a:ext>
                  </a:extLst>
                </a:gridCol>
              </a:tblGrid>
              <a:tr h="47888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te</a:t>
                      </a:r>
                      <a:endParaRPr lang="zh-CN" sz="1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ufacturer</a:t>
                      </a:r>
                      <a:endParaRPr lang="zh-CN" sz="1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alog Number</a:t>
                      </a:r>
                      <a:endParaRPr lang="zh-CN" sz="1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a-assay CV</a:t>
                      </a:r>
                      <a:endParaRPr lang="zh-CN" sz="1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-assay CV</a:t>
                      </a:r>
                      <a:endParaRPr lang="zh-CN" sz="1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D</a:t>
                      </a:r>
                      <a:endParaRPr lang="zh-CN" sz="1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ibration Range</a:t>
                      </a:r>
                      <a:endParaRPr lang="zh-CN" sz="1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89491542"/>
                  </a:ext>
                </a:extLst>
              </a:tr>
              <a:tr h="5028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nin-1 (ng/mL)</a:t>
                      </a:r>
                      <a:endParaRPr lang="zh-CN" sz="1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nghai sinobestbio technology Co., Ltd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X-E23022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– 8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7737795"/>
                  </a:ext>
                </a:extLst>
              </a:tr>
              <a:tr h="5028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4 (pg/mL)</a:t>
                      </a:r>
                      <a:endParaRPr lang="zh-CN" sz="1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nghai sinobestbio technology Co., Ltd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X-E10142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–2000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33758107"/>
                  </a:ext>
                </a:extLst>
              </a:tr>
              <a:tr h="5028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3 (pg/mL)</a:t>
                      </a:r>
                      <a:endParaRPr lang="zh-CN" sz="1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nghai </a:t>
                      </a:r>
                      <a:r>
                        <a:rPr lang="en-US" sz="140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nobestbio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echnology Co., Ltd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X-E10152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–2000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17547316"/>
                  </a:ext>
                </a:extLst>
              </a:tr>
              <a:tr h="5028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-17 (pg/mL)</a:t>
                      </a:r>
                      <a:endParaRPr lang="zh-CN" sz="1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nghai sinobestbio technology Co., Ltd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X-E10082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–4800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48960328"/>
                  </a:ext>
                </a:extLst>
              </a:tr>
              <a:tr h="50285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-</a:t>
                      </a:r>
                      <a:r>
                        <a:rPr lang="zh-CN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</a:t>
                      </a: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1400" b="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</a:t>
                      </a: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lang="zh-CN" sz="1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nghai sinobestbio technology Co., Ltd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X-E10162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–800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36225197"/>
                  </a:ext>
                </a:extLst>
              </a:tr>
              <a:tr h="34038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altLang="zh-CN" sz="14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IgE</a:t>
                      </a:r>
                      <a:r>
                        <a:rPr lang="en-US" altLang="zh-CN" sz="1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altLang="zh-CN" sz="1400" b="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U</a:t>
                      </a:r>
                      <a:r>
                        <a:rPr lang="en-US" altLang="zh-CN" sz="1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L)</a:t>
                      </a:r>
                      <a:endParaRPr lang="zh-CN" sz="1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altLang="zh-CN" sz="14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ermo</a:t>
                      </a:r>
                      <a:r>
                        <a:rPr lang="en-US" altLang="zh-CN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Fisher Scientific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altLang="zh-CN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2-5461-CN/04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alt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altLang="zh-CN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zh-CN" alt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–5000 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35158056"/>
                  </a:ext>
                </a:extLst>
              </a:tr>
              <a:tr h="34038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dford Protein Assay</a:t>
                      </a:r>
                      <a:endParaRPr lang="zh-CN" sz="1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-Rad (USA)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-0210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03349635"/>
                  </a:ext>
                </a:extLst>
              </a:tr>
              <a:tr h="44191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ARS Assay</a:t>
                      </a:r>
                      <a:endParaRPr lang="zh-CN" sz="1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400" b="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mol</a:t>
                      </a: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  <a:endParaRPr lang="zh-CN" sz="1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-BC-K298-M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–100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56969601"/>
                  </a:ext>
                </a:extLst>
              </a:tr>
              <a:tr h="617062"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lorimetric Assay Kit (</a:t>
                      </a:r>
                      <a:r>
                        <a:rPr lang="en-US" sz="1400" b="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μmol</a:t>
                      </a:r>
                      <a:r>
                        <a:rPr lang="en-US" sz="1400" b="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L)</a:t>
                      </a:r>
                      <a:endParaRPr lang="zh-CN" altLang="en-US" sz="1400" b="0" kern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abscience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iotechnology </a:t>
                      </a:r>
                      <a:r>
                        <a:rPr lang="en-US" sz="140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.,Ltd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-BC-K030-M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%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zh-CN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zh-CN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4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zh-CN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815" marR="6381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315836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91705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796</TotalTime>
  <Words>191</Words>
  <Application>Microsoft Office PowerPoint</Application>
  <PresentationFormat>Custom</PresentationFormat>
  <Paragraphs>7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媛媛 吴</dc:creator>
  <cp:lastModifiedBy>Antonieta Decipolo</cp:lastModifiedBy>
  <cp:revision>72</cp:revision>
  <dcterms:created xsi:type="dcterms:W3CDTF">2025-10-01T15:15:34Z</dcterms:created>
  <dcterms:modified xsi:type="dcterms:W3CDTF">2026-04-24T11:33:39Z</dcterms:modified>
</cp:coreProperties>
</file>